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9" r:id="rId3"/>
    <p:sldId id="257" r:id="rId4"/>
    <p:sldId id="258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08" autoAdjust="0"/>
    <p:restoredTop sz="94660"/>
  </p:normalViewPr>
  <p:slideViewPr>
    <p:cSldViewPr snapToGrid="0">
      <p:cViewPr varScale="1">
        <p:scale>
          <a:sx n="81" d="100"/>
          <a:sy n="81" d="100"/>
        </p:scale>
        <p:origin x="739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C7F21E-2BC2-414A-A065-6AAF26A5EC63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ED0BD6-9DE6-4CB8-B77D-AC959CA9F4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091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ED0BD6-9DE6-4CB8-B77D-AC959CA9F41E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4447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0B1008-C9D0-4B24-9C63-E2D9B072D9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07AC0CD-D0BC-4490-90D3-148436E05B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6727F3-3233-415E-850F-838E07C85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511DCF-2C4A-4375-8D4E-44D2B252C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BADFB8-C216-47B5-A02F-46EA56BB1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094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101C8C-DCCB-4EEC-85BF-F555FA739A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DFA3AA0-9CA2-4140-94C6-D2A4C8921E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14A4C1-BD7C-48D1-B1B3-CDD42BA90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6E1188-F034-45EB-A7DF-7D1A75839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E49F6D-BD0A-4BCB-9113-7453D8282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106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98DBFD4-3EFF-4B5B-82EA-2B512FB7B5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8D097A8-10BC-469E-91B6-BACC728634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9DB185-6F08-4195-8419-6D4EC6126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2851C2-A475-46A1-9492-4B46C2202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BE82DF-A974-4E00-A69E-653778E4D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27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FAD3A3-529B-4480-9A6F-42E328CD5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F82085-A001-458B-9C29-9D3C1730E2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D77BE1-8A85-4F8C-9889-AE1DE29A3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60DCD5-229A-43F8-8FBE-23484FEDF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B4BE83-0090-4947-A1EA-2E3192770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47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FCFBA2-F6BF-4EEA-8AE2-0029BF9FB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A7FB975-46C1-4826-B50D-6E066AE8EF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44C88D-D781-4381-B524-5CAB7A541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4BC153-BD3F-4232-9AFE-20BD7F0B8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F6DB78-5770-4801-AE13-A1459D419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1576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AF2130-E775-4D8E-BC88-D328EA469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86E548B-67CF-4828-B9AE-15FAC9F0E2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78BE364-4E79-4255-ABD0-4D52892DD4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8ABEC3-AB4A-4D2A-A1AB-14315E48C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7B774C0-BFF9-42FF-86B1-9858FEDCB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E495CF-3380-4BE2-AD23-E95C7AAED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5314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E530BF-8DBF-407F-8FD6-FF9E39E878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AC7AF08-2C62-40DC-8B1C-B35038EE0E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C6BE6D7-0A42-4245-BB19-0CD344432F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0723044-5513-4678-8BB1-FA9DC62BD9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ADFEFEC-DDE7-456F-89FA-11D3BB3ECD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76A2E15-1238-4B24-A5FB-9F6210BBB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B770CFA-4D4C-4530-91B1-AF013D54B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8DA9D6F-9691-49E3-BB8F-C3BA32C24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0204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C9753B-44DF-4FD8-A2E4-112362FEB5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E58181C-EA74-4887-8A61-52D1DDEF2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A395FA1-496E-42F1-9573-58B80E9C5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CD0E20B-E517-4E00-91FE-3DB39368E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453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B50862A-E8F7-4BC6-8F64-EFE430DA9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B959D98-E3C5-43EB-BCCE-623361322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F3F3556-1E7F-451A-AE4F-77F6F5D37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6999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DDD178-443E-4659-910C-7D5038B77F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93E64E-21D5-4F5D-ADFD-DEE8BC7571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3378528-AC0E-4430-8470-2D02FDD635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C6150B2-32D8-41C3-A719-31AD6E5F7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C86A62-2C1A-4B06-AED6-04671C77F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813B7E7-10B9-4035-8E15-9C479950E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5317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F4E350-0FB7-4220-859D-0BA072A0D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0F6E5FD-BC9F-4F04-8431-D8D0B49C60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1CDF21-3733-4B5B-8874-79931FCDCE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182283-40BF-4F9A-AECB-D2A6DFCFA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86DD11-FE15-43F2-A1BF-9F94D69CC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8FE241F-2487-4B89-83A6-1D9F806D8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1999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EDD66FD-DDDB-4A7A-B51E-AD420DB60F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0D1180D-BB0C-44D7-ABED-3E679A997D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70B71D-DA2E-440B-A19D-75E2081520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820EB-EF31-41AA-A25E-AD3D2E646308}" type="datetimeFigureOut">
              <a:rPr lang="zh-CN" altLang="en-US" smtClean="0"/>
              <a:t>2022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639AAC-2A18-4CE9-A033-DD6B0745D5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692B3C-53D4-4DE8-9D71-7F4B82166B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243A92-A0B7-421F-B6F1-11E7AE68A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1652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openxmlformats.org/officeDocument/2006/relationships/image" Target="../media/image48.png"/><Relationship Id="rId7" Type="http://schemas.openxmlformats.org/officeDocument/2006/relationships/image" Target="../media/image51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26.png"/><Relationship Id="rId9" Type="http://schemas.openxmlformats.org/officeDocument/2006/relationships/image" Target="../media/image5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2594F4EE-E226-4EA8-8026-AD6EBAF12A32}"/>
              </a:ext>
            </a:extLst>
          </p:cNvPr>
          <p:cNvSpPr txBox="1"/>
          <p:nvPr/>
        </p:nvSpPr>
        <p:spPr>
          <a:xfrm>
            <a:off x="2649140" y="1823233"/>
            <a:ext cx="680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   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84237E9A-725D-4799-B859-B9786CE0F7C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011" y="1823233"/>
            <a:ext cx="1260000" cy="119265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BE44777-2DA7-46CC-8617-E86AC962E8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466" y="3015889"/>
            <a:ext cx="5328366" cy="2145978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30E6AD8-9CCD-42BE-80A6-5D8529074EE3}"/>
              </a:ext>
            </a:extLst>
          </p:cNvPr>
          <p:cNvCxnSpPr/>
          <p:nvPr/>
        </p:nvCxnSpPr>
        <p:spPr>
          <a:xfrm>
            <a:off x="592836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图片 21">
            <a:extLst>
              <a:ext uri="{FF2B5EF4-FFF2-40B4-BE49-F238E27FC236}">
                <a16:creationId xmlns:a16="http://schemas.microsoft.com/office/drawing/2014/main" id="{E484941D-8593-4F55-B473-AC21D2EB93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7184" y="1045371"/>
            <a:ext cx="5328366" cy="2145978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AEA4272F-65E6-4343-BD36-47608AB1D672}"/>
              </a:ext>
            </a:extLst>
          </p:cNvPr>
          <p:cNvSpPr txBox="1"/>
          <p:nvPr/>
        </p:nvSpPr>
        <p:spPr>
          <a:xfrm>
            <a:off x="8931720" y="69431"/>
            <a:ext cx="1182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N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5E9173FF-A25B-4C2C-A1D2-7F1EE80AA48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8028" y="21781"/>
            <a:ext cx="1260000" cy="1376267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241E2791-4E87-437B-B26C-ED737A68AF9F}"/>
              </a:ext>
            </a:extLst>
          </p:cNvPr>
          <p:cNvSpPr txBox="1"/>
          <p:nvPr/>
        </p:nvSpPr>
        <p:spPr>
          <a:xfrm>
            <a:off x="8317304" y="405525"/>
            <a:ext cx="38746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ADA1325-D507-45ED-8BF2-CF953446E251}"/>
              </a:ext>
            </a:extLst>
          </p:cNvPr>
          <p:cNvSpPr txBox="1"/>
          <p:nvPr/>
        </p:nvSpPr>
        <p:spPr>
          <a:xfrm>
            <a:off x="7922861" y="3497755"/>
            <a:ext cx="2732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NB (4-Nitrobenzoic acid)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84DB0D5-CA1D-411F-85F9-6B36CD8736FE}"/>
              </a:ext>
            </a:extLst>
          </p:cNvPr>
          <p:cNvSpPr txBox="1"/>
          <p:nvPr/>
        </p:nvSpPr>
        <p:spPr>
          <a:xfrm>
            <a:off x="8820769" y="3889415"/>
            <a:ext cx="1308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ndards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1048B433-702D-4B8C-BAA5-6D52EF5C717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17184" y="4276014"/>
            <a:ext cx="5328366" cy="2176461"/>
          </a:xfrm>
          <a:prstGeom prst="rect">
            <a:avLst/>
          </a:prstGeom>
        </p:spPr>
      </p:pic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1989F298-FDAA-42D7-8A0D-18B8349047F8}"/>
              </a:ext>
            </a:extLst>
          </p:cNvPr>
          <p:cNvCxnSpPr>
            <a:cxnSpLocks/>
          </p:cNvCxnSpPr>
          <p:nvPr/>
        </p:nvCxnSpPr>
        <p:spPr>
          <a:xfrm>
            <a:off x="5928360" y="3435541"/>
            <a:ext cx="626364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F3630DF0-3DF4-3136-0F7C-DAFB88A5E6C4}"/>
              </a:ext>
            </a:extLst>
          </p:cNvPr>
          <p:cNvSpPr txBox="1"/>
          <p:nvPr/>
        </p:nvSpPr>
        <p:spPr>
          <a:xfrm>
            <a:off x="335699" y="399040"/>
            <a:ext cx="5086970" cy="707886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S/MS spectra of CAP and its products determined by HPLC-QTOF-MS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17E8731-CE79-FC50-D057-464EFED0A425}"/>
              </a:ext>
            </a:extLst>
          </p:cNvPr>
          <p:cNvSpPr txBox="1"/>
          <p:nvPr/>
        </p:nvSpPr>
        <p:spPr>
          <a:xfrm>
            <a:off x="4197060" y="3359006"/>
            <a:ext cx="707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0" u="none" strike="noStrike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</a:t>
            </a:r>
            <a:endParaRPr lang="en-US" altLang="zh-CN" sz="1600" i="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8680375-7552-FF27-533D-E13250AFD4D7}"/>
              </a:ext>
            </a:extLst>
          </p:cNvPr>
          <p:cNvSpPr txBox="1"/>
          <p:nvPr/>
        </p:nvSpPr>
        <p:spPr>
          <a:xfrm>
            <a:off x="4693038" y="3359006"/>
            <a:ext cx="5946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0" u="none" strike="noStrike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T</a:t>
            </a:r>
            <a:endParaRPr lang="en-US" altLang="zh-CN" sz="1600" i="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E775210-3C1C-811D-D9C1-D8DEC761F153}"/>
              </a:ext>
            </a:extLst>
          </p:cNvPr>
          <p:cNvSpPr txBox="1"/>
          <p:nvPr/>
        </p:nvSpPr>
        <p:spPr>
          <a:xfrm>
            <a:off x="1362002" y="5535630"/>
            <a:ext cx="334746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/z:</a:t>
            </a:r>
            <a:r>
              <a:rPr lang="zh-CN" alt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ss-to-charge ratio</a:t>
            </a:r>
          </a:p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: Collision energy</a:t>
            </a:r>
          </a:p>
          <a:p>
            <a:r>
              <a:rPr lang="en-US" altLang="zh-CN" sz="1800" i="0" u="none" strike="noStrike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T: Retention time</a:t>
            </a:r>
            <a:endParaRPr lang="en-US" altLang="zh-CN" sz="1800" i="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2378697-2EDB-7B6A-DF51-5DAC1CEA7D3F}"/>
              </a:ext>
            </a:extLst>
          </p:cNvPr>
          <p:cNvSpPr txBox="1"/>
          <p:nvPr/>
        </p:nvSpPr>
        <p:spPr>
          <a:xfrm>
            <a:off x="2847917" y="3303365"/>
            <a:ext cx="8795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m/z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66C92DB-4A49-10E4-E708-C26E5B9AB33E}"/>
              </a:ext>
            </a:extLst>
          </p:cNvPr>
          <p:cNvSpPr txBox="1"/>
          <p:nvPr/>
        </p:nvSpPr>
        <p:spPr>
          <a:xfrm>
            <a:off x="3601042" y="3349940"/>
            <a:ext cx="707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 u="none" strike="noStrike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endParaRPr lang="en-US" altLang="zh-CN" sz="1600" i="1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D5ED67CC-EF63-2850-A5FA-6FFFF9E7FB94}"/>
              </a:ext>
            </a:extLst>
          </p:cNvPr>
          <p:cNvCxnSpPr>
            <a:cxnSpLocks/>
          </p:cNvCxnSpPr>
          <p:nvPr/>
        </p:nvCxnSpPr>
        <p:spPr>
          <a:xfrm>
            <a:off x="3834307" y="3214054"/>
            <a:ext cx="0" cy="23091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B5BB50BC-5D22-2776-5B15-371D973DB3A0}"/>
              </a:ext>
            </a:extLst>
          </p:cNvPr>
          <p:cNvCxnSpPr>
            <a:cxnSpLocks/>
          </p:cNvCxnSpPr>
          <p:nvPr/>
        </p:nvCxnSpPr>
        <p:spPr>
          <a:xfrm>
            <a:off x="4439194" y="3198620"/>
            <a:ext cx="0" cy="23091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4C911154-B5EF-0E15-FDB5-E359E68BE87F}"/>
              </a:ext>
            </a:extLst>
          </p:cNvPr>
          <p:cNvCxnSpPr>
            <a:cxnSpLocks/>
          </p:cNvCxnSpPr>
          <p:nvPr/>
        </p:nvCxnSpPr>
        <p:spPr>
          <a:xfrm>
            <a:off x="4885513" y="3192613"/>
            <a:ext cx="0" cy="23091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09162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45A916F-09B8-456B-8702-FD3AE0DA11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7685" y="1045371"/>
            <a:ext cx="5334462" cy="2145978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592836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4753F18B-BF45-4AB0-824A-873BB8C00BB1}"/>
              </a:ext>
            </a:extLst>
          </p:cNvPr>
          <p:cNvSpPr txBox="1"/>
          <p:nvPr/>
        </p:nvSpPr>
        <p:spPr>
          <a:xfrm>
            <a:off x="2611922" y="57079"/>
            <a:ext cx="1038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909B13A-DA98-4783-BBD2-303EFA3B241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371" y="76505"/>
            <a:ext cx="1080000" cy="901104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7191E1E5-00C7-4B8C-94C7-50912A832006}"/>
              </a:ext>
            </a:extLst>
          </p:cNvPr>
          <p:cNvSpPr txBox="1"/>
          <p:nvPr/>
        </p:nvSpPr>
        <p:spPr>
          <a:xfrm>
            <a:off x="2106580" y="405183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25CF4A3-BBFB-4756-B6C5-107F54E298C4}"/>
              </a:ext>
            </a:extLst>
          </p:cNvPr>
          <p:cNvSpPr txBox="1"/>
          <p:nvPr/>
        </p:nvSpPr>
        <p:spPr>
          <a:xfrm>
            <a:off x="1753391" y="3477445"/>
            <a:ext cx="3364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CA (2,2-Dichloroacetic acid)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5D17D8B-FFEE-48E3-A30C-92F1495D83A3}"/>
              </a:ext>
            </a:extLst>
          </p:cNvPr>
          <p:cNvSpPr txBox="1"/>
          <p:nvPr/>
        </p:nvSpPr>
        <p:spPr>
          <a:xfrm>
            <a:off x="2528198" y="3869105"/>
            <a:ext cx="1308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ndards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4AA27FFF-D62F-4B6F-ACB0-91A384E75B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223" y="1045371"/>
            <a:ext cx="5322269" cy="2145978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067D73D4-F141-46CB-8D1C-C419E45D5C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223" y="4306497"/>
            <a:ext cx="5328366" cy="2145978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444E8DEC-3F27-48F9-B8ED-DF92894F5B23}"/>
              </a:ext>
            </a:extLst>
          </p:cNvPr>
          <p:cNvSpPr txBox="1"/>
          <p:nvPr/>
        </p:nvSpPr>
        <p:spPr>
          <a:xfrm>
            <a:off x="8907964" y="119694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8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F04F799-F816-4AA0-8BD3-B330AFA67C46}"/>
              </a:ext>
            </a:extLst>
          </p:cNvPr>
          <p:cNvSpPr txBox="1"/>
          <p:nvPr/>
        </p:nvSpPr>
        <p:spPr>
          <a:xfrm>
            <a:off x="8377785" y="521897"/>
            <a:ext cx="3814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B2256DF-132F-4F98-8483-28853A70BB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37685" y="4306497"/>
            <a:ext cx="5322269" cy="2145978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817A4E0C-8961-4A56-83C4-33198177CA3F}"/>
              </a:ext>
            </a:extLst>
          </p:cNvPr>
          <p:cNvSpPr txBox="1"/>
          <p:nvPr/>
        </p:nvSpPr>
        <p:spPr>
          <a:xfrm>
            <a:off x="7701333" y="3477445"/>
            <a:ext cx="3403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286</a:t>
            </a:r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4,4'-Azoxydibenzoic acid)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D05893F-BC89-4459-90A0-7BFD780D0115}"/>
              </a:ext>
            </a:extLst>
          </p:cNvPr>
          <p:cNvSpPr txBox="1"/>
          <p:nvPr/>
        </p:nvSpPr>
        <p:spPr>
          <a:xfrm>
            <a:off x="8760299" y="3898434"/>
            <a:ext cx="1308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ndards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DEFD6035-BF3A-4439-ABCB-8D44CBD618C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80491" y="-11105"/>
            <a:ext cx="1926739" cy="1474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2241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6C5F2A5F-E2A7-4536-A2BE-10D49DD807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488" y="1076999"/>
            <a:ext cx="5328366" cy="2145978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44BE02FE-AE36-4F96-97B6-7A4092E48B73}"/>
              </a:ext>
            </a:extLst>
          </p:cNvPr>
          <p:cNvSpPr txBox="1"/>
          <p:nvPr/>
        </p:nvSpPr>
        <p:spPr>
          <a:xfrm>
            <a:off x="1348488" y="3520083"/>
            <a:ext cx="4109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</a:t>
            </a:r>
            <a:r>
              <a:rPr lang="en-GB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 (Chloramphenicol 3-acetate)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F6B2CC1-E58E-45D3-8DC5-426D8CE03D6B}"/>
              </a:ext>
            </a:extLst>
          </p:cNvPr>
          <p:cNvSpPr txBox="1"/>
          <p:nvPr/>
        </p:nvSpPr>
        <p:spPr>
          <a:xfrm>
            <a:off x="2623463" y="3911743"/>
            <a:ext cx="1308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ndards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50A3108-35BB-44B0-9DC4-95ACA5F6BC41}"/>
              </a:ext>
            </a:extLst>
          </p:cNvPr>
          <p:cNvSpPr txBox="1"/>
          <p:nvPr/>
        </p:nvSpPr>
        <p:spPr>
          <a:xfrm>
            <a:off x="2715374" y="114439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2ADFCE3-E493-4D95-A2C9-CD7E70BA254B}"/>
              </a:ext>
            </a:extLst>
          </p:cNvPr>
          <p:cNvSpPr txBox="1"/>
          <p:nvPr/>
        </p:nvSpPr>
        <p:spPr>
          <a:xfrm>
            <a:off x="2506098" y="506099"/>
            <a:ext cx="3725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priavid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 CLC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5165420-1ACC-44CE-83D0-56A3A683464E}"/>
              </a:ext>
            </a:extLst>
          </p:cNvPr>
          <p:cNvSpPr txBox="1"/>
          <p:nvPr/>
        </p:nvSpPr>
        <p:spPr>
          <a:xfrm>
            <a:off x="8925674" y="114439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44D30F2-6856-4D4B-955E-1A657972B20F}"/>
              </a:ext>
            </a:extLst>
          </p:cNvPr>
          <p:cNvSpPr txBox="1"/>
          <p:nvPr/>
        </p:nvSpPr>
        <p:spPr>
          <a:xfrm>
            <a:off x="8281016" y="461878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B165F98-F7C4-4E87-8FD3-6D5ED4D99A98}"/>
              </a:ext>
            </a:extLst>
          </p:cNvPr>
          <p:cNvSpPr txBox="1"/>
          <p:nvPr/>
        </p:nvSpPr>
        <p:spPr>
          <a:xfrm>
            <a:off x="7376110" y="3497755"/>
            <a:ext cx="38040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S-</a:t>
            </a:r>
            <a:r>
              <a:rPr lang="en-GB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 (L-erythro-Chloramphenicol)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7FE4C61-AE39-472A-A846-574971DB5DFF}"/>
              </a:ext>
            </a:extLst>
          </p:cNvPr>
          <p:cNvSpPr txBox="1"/>
          <p:nvPr/>
        </p:nvSpPr>
        <p:spPr>
          <a:xfrm>
            <a:off x="8820769" y="3889415"/>
            <a:ext cx="1308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ndards</a:t>
            </a:r>
            <a:endParaRPr lang="zh-CN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A2169AF0-B1C7-4D53-B250-915D1F5913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2147" y="1076999"/>
            <a:ext cx="5328366" cy="214597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6E9B4E09-1C91-4612-9F8C-610AED86AB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1488" y="4365616"/>
            <a:ext cx="5328366" cy="213988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B4E810A-5CAE-4987-B484-344E94F1D6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62147" y="4347326"/>
            <a:ext cx="5322269" cy="215817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08071A37-260E-4246-9BAA-AC08B7A157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8329" y="43249"/>
            <a:ext cx="1585261" cy="13291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95725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3044C57F-FCE0-4454-869B-075AD60068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95530" y="944834"/>
            <a:ext cx="5328366" cy="2145978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图片 5">
            <a:extLst>
              <a:ext uri="{FF2B5EF4-FFF2-40B4-BE49-F238E27FC236}">
                <a16:creationId xmlns:a16="http://schemas.microsoft.com/office/drawing/2014/main" id="{64BF9152-BD3E-4BA1-BF68-1CCD9BE7DF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106" y="944834"/>
            <a:ext cx="5328366" cy="214597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E38EB20-4694-4833-A440-5CA99208EABC}"/>
              </a:ext>
            </a:extLst>
          </p:cNvPr>
          <p:cNvSpPr txBox="1"/>
          <p:nvPr/>
        </p:nvSpPr>
        <p:spPr>
          <a:xfrm>
            <a:off x="2810582" y="15240"/>
            <a:ext cx="929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457C8618-449B-469B-8542-B809D2B8A1D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928" y="73283"/>
            <a:ext cx="2160000" cy="110003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4EE023D-D0E0-4D9F-943A-1673F7B0D3F9}"/>
              </a:ext>
            </a:extLst>
          </p:cNvPr>
          <p:cNvSpPr txBox="1"/>
          <p:nvPr/>
        </p:nvSpPr>
        <p:spPr>
          <a:xfrm>
            <a:off x="2402171" y="310952"/>
            <a:ext cx="4120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92DD375-0F7E-4B6C-A489-31BED24CFE4F}"/>
              </a:ext>
            </a:extLst>
          </p:cNvPr>
          <p:cNvSpPr txBox="1"/>
          <p:nvPr/>
        </p:nvSpPr>
        <p:spPr>
          <a:xfrm>
            <a:off x="1848405" y="3530884"/>
            <a:ext cx="3290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P (stereoisomeric O-CAP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2078216-BA03-4DDB-9285-B63A1F288F49}"/>
              </a:ext>
            </a:extLst>
          </p:cNvPr>
          <p:cNvSpPr txBox="1"/>
          <p:nvPr/>
        </p:nvSpPr>
        <p:spPr>
          <a:xfrm>
            <a:off x="1606374" y="3942546"/>
            <a:ext cx="3851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445A412-261C-4649-A2E2-60EE3DAACF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8106" y="4395841"/>
            <a:ext cx="5328366" cy="2139881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9E0AE9D9-7B8A-4A61-A51B-854CA1E71C0C}"/>
              </a:ext>
            </a:extLst>
          </p:cNvPr>
          <p:cNvSpPr txBox="1"/>
          <p:nvPr/>
        </p:nvSpPr>
        <p:spPr>
          <a:xfrm>
            <a:off x="8772989" y="13424"/>
            <a:ext cx="1168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4E02ECB8-47AF-440D-9B12-0216AD8B0FE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7535" y="-17056"/>
            <a:ext cx="2340000" cy="1129869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D45BF2E7-B6A5-44F9-97BD-4F8E3786DC53}"/>
              </a:ext>
            </a:extLst>
          </p:cNvPr>
          <p:cNvSpPr txBox="1"/>
          <p:nvPr/>
        </p:nvSpPr>
        <p:spPr>
          <a:xfrm>
            <a:off x="8476250" y="305433"/>
            <a:ext cx="38088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8C4435F-CCDA-4EFD-8665-B8973F2300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01625" y="4389744"/>
            <a:ext cx="5322269" cy="2145978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D5119184-F401-43AA-BFEB-EE42B6F47444}"/>
              </a:ext>
            </a:extLst>
          </p:cNvPr>
          <p:cNvSpPr txBox="1"/>
          <p:nvPr/>
        </p:nvSpPr>
        <p:spPr>
          <a:xfrm>
            <a:off x="8656476" y="3558085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E2C24D9-36CA-49A2-BC6B-C21E64ACD920}"/>
              </a:ext>
            </a:extLst>
          </p:cNvPr>
          <p:cNvSpPr txBox="1"/>
          <p:nvPr/>
        </p:nvSpPr>
        <p:spPr>
          <a:xfrm>
            <a:off x="8156860" y="3927417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2768BC77-4359-409A-8BDB-45FD56F21EF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6630" y="3477420"/>
            <a:ext cx="1980000" cy="10615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04271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A4F8C0A-C318-457D-98CB-ECA6924AFA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6752" y="1029267"/>
            <a:ext cx="5328366" cy="214597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678F44C2-BDEE-4A60-AC2E-67351364ED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752" y="4298409"/>
            <a:ext cx="5328366" cy="214597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80EDFCD-E648-4461-A099-CC6AABD7D5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36881" y="1029267"/>
            <a:ext cx="5322269" cy="2145978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06BB522-C241-40A9-A11A-2921F5988CF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36881" y="4315968"/>
            <a:ext cx="5322269" cy="2145978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0BC9A036-347A-4995-8470-573B6275043A}"/>
              </a:ext>
            </a:extLst>
          </p:cNvPr>
          <p:cNvSpPr txBox="1"/>
          <p:nvPr/>
        </p:nvSpPr>
        <p:spPr>
          <a:xfrm>
            <a:off x="2667900" y="0"/>
            <a:ext cx="1182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F1509B8F-33BF-453B-BE7B-97C2A12E0BD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236" y="76160"/>
            <a:ext cx="1980000" cy="107413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75D3753C-FBBC-40CD-BE45-B28E946C2D2B}"/>
              </a:ext>
            </a:extLst>
          </p:cNvPr>
          <p:cNvSpPr txBox="1"/>
          <p:nvPr/>
        </p:nvSpPr>
        <p:spPr>
          <a:xfrm>
            <a:off x="2288964" y="369332"/>
            <a:ext cx="40351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34BCAE7-BE04-493F-973A-3A15F2B01A43}"/>
              </a:ext>
            </a:extLst>
          </p:cNvPr>
          <p:cNvSpPr txBox="1"/>
          <p:nvPr/>
        </p:nvSpPr>
        <p:spPr>
          <a:xfrm>
            <a:off x="2805494" y="3447733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18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7852C855-7A60-4950-B28E-51524537EF2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6123" y="3461789"/>
            <a:ext cx="1440000" cy="120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FB824BDC-E330-4E4A-A4C2-7094131FE176}"/>
              </a:ext>
            </a:extLst>
          </p:cNvPr>
          <p:cNvSpPr txBox="1"/>
          <p:nvPr/>
        </p:nvSpPr>
        <p:spPr>
          <a:xfrm>
            <a:off x="2161681" y="3695838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124E6CB-F0C2-4761-9C38-FAE0002BCE12}"/>
              </a:ext>
            </a:extLst>
          </p:cNvPr>
          <p:cNvSpPr txBox="1"/>
          <p:nvPr/>
        </p:nvSpPr>
        <p:spPr>
          <a:xfrm>
            <a:off x="9117500" y="71297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17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2DD18056-B79D-4BB8-A62C-53B4F8A3264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4623" y="112785"/>
            <a:ext cx="1440000" cy="86574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92331654-CB6A-4096-8F22-3DE7A7BCAAAE}"/>
              </a:ext>
            </a:extLst>
          </p:cNvPr>
          <p:cNvSpPr txBox="1"/>
          <p:nvPr/>
        </p:nvSpPr>
        <p:spPr>
          <a:xfrm>
            <a:off x="8438300" y="393985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9827490-61D4-462B-9159-3A395F602D28}"/>
              </a:ext>
            </a:extLst>
          </p:cNvPr>
          <p:cNvSpPr txBox="1"/>
          <p:nvPr/>
        </p:nvSpPr>
        <p:spPr>
          <a:xfrm>
            <a:off x="9117499" y="3445998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16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3D203702-FA30-4626-9966-D710F68E85E6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7962" y="3499079"/>
            <a:ext cx="1440000" cy="968108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251CB4CE-7FF9-4715-8E3E-4E75E2A9C7CC}"/>
              </a:ext>
            </a:extLst>
          </p:cNvPr>
          <p:cNvSpPr txBox="1"/>
          <p:nvPr/>
        </p:nvSpPr>
        <p:spPr>
          <a:xfrm>
            <a:off x="8438300" y="3723078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27327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03FE9EB5-C544-450C-A3BC-CB769F0838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7535" y="4400967"/>
            <a:ext cx="5322269" cy="213988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F46DC93-BE91-45E6-A269-CA77FD5339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7535" y="990197"/>
            <a:ext cx="5322269" cy="214597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BF51EBC-65F9-41A4-802C-3F8099634A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2197" y="4405341"/>
            <a:ext cx="5322269" cy="2139881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图片 1">
            <a:extLst>
              <a:ext uri="{FF2B5EF4-FFF2-40B4-BE49-F238E27FC236}">
                <a16:creationId xmlns:a16="http://schemas.microsoft.com/office/drawing/2014/main" id="{9CC10542-1485-4CF9-A248-2F53DE37CF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6100" y="993246"/>
            <a:ext cx="5328366" cy="213988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19648D5-FF61-41F0-B111-54DAEAF4D347}"/>
              </a:ext>
            </a:extLst>
          </p:cNvPr>
          <p:cNvSpPr txBox="1"/>
          <p:nvPr/>
        </p:nvSpPr>
        <p:spPr>
          <a:xfrm>
            <a:off x="2756828" y="97706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2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F3BCCE1-2038-4941-8644-D749052334FC}"/>
              </a:ext>
            </a:extLst>
          </p:cNvPr>
          <p:cNvSpPr txBox="1"/>
          <p:nvPr/>
        </p:nvSpPr>
        <p:spPr>
          <a:xfrm>
            <a:off x="2366532" y="403749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EEA485D-A375-479E-B6BE-882DDE07C183}"/>
              </a:ext>
            </a:extLst>
          </p:cNvPr>
          <p:cNvSpPr txBox="1"/>
          <p:nvPr/>
        </p:nvSpPr>
        <p:spPr>
          <a:xfrm>
            <a:off x="2725181" y="3514652"/>
            <a:ext cx="260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0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3432CFB6-FA42-4067-9779-BD552FA50BC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825" y="3500340"/>
            <a:ext cx="1440000" cy="108847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B19DA053-02FB-4AD2-AF59-C1948DA5CAFA}"/>
              </a:ext>
            </a:extLst>
          </p:cNvPr>
          <p:cNvSpPr txBox="1"/>
          <p:nvPr/>
        </p:nvSpPr>
        <p:spPr>
          <a:xfrm>
            <a:off x="2175550" y="3883504"/>
            <a:ext cx="3702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406D5B8-79D3-4C78-9981-AE0E8F6B80B3}"/>
              </a:ext>
            </a:extLst>
          </p:cNvPr>
          <p:cNvSpPr txBox="1"/>
          <p:nvPr/>
        </p:nvSpPr>
        <p:spPr>
          <a:xfrm>
            <a:off x="8914498" y="33263"/>
            <a:ext cx="1038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27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9422048-2312-4F41-AF00-D551E42AD83B}"/>
              </a:ext>
            </a:extLst>
          </p:cNvPr>
          <p:cNvSpPr txBox="1"/>
          <p:nvPr/>
        </p:nvSpPr>
        <p:spPr>
          <a:xfrm>
            <a:off x="8454260" y="370071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8D698EE-8457-406E-918C-03AD0B2CC9DE}"/>
              </a:ext>
            </a:extLst>
          </p:cNvPr>
          <p:cNvSpPr txBox="1"/>
          <p:nvPr/>
        </p:nvSpPr>
        <p:spPr>
          <a:xfrm>
            <a:off x="8200790" y="3466981"/>
            <a:ext cx="3120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27b (stereoisomeric P-227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2790F71-CF57-41D5-B297-A9321FA8F0AF}"/>
              </a:ext>
            </a:extLst>
          </p:cNvPr>
          <p:cNvSpPr txBox="1"/>
          <p:nvPr/>
        </p:nvSpPr>
        <p:spPr>
          <a:xfrm>
            <a:off x="8339969" y="3794506"/>
            <a:ext cx="40351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 an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70AB4E9F-AE8F-4D99-8D6D-41B57258AC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7732" y="66302"/>
            <a:ext cx="1918328" cy="121685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D883109-FCDF-4D1B-AB4F-0B31EACAD4D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52927" y="11331"/>
            <a:ext cx="1801333" cy="12718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58759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3CD26B0A-9BFD-43B6-86FE-96BCC5A2A5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045" y="1057691"/>
            <a:ext cx="5328366" cy="213988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4C6D0CDD-ABC3-4F1B-A244-8AD816EEF5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1589" y="1063659"/>
            <a:ext cx="5328366" cy="2139881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0FE39184-39B3-4E58-9B42-A6CCA1D9A904}"/>
              </a:ext>
            </a:extLst>
          </p:cNvPr>
          <p:cNvSpPr txBox="1"/>
          <p:nvPr/>
        </p:nvSpPr>
        <p:spPr>
          <a:xfrm>
            <a:off x="2661696" y="21812"/>
            <a:ext cx="1038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195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24E5F1E-5E13-44AE-AB05-20883E1383A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542" y="17782"/>
            <a:ext cx="1440000" cy="1335405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4153A252-4190-44EC-847B-70604CC28EFF}"/>
              </a:ext>
            </a:extLst>
          </p:cNvPr>
          <p:cNvSpPr txBox="1"/>
          <p:nvPr/>
        </p:nvSpPr>
        <p:spPr>
          <a:xfrm>
            <a:off x="2198935" y="411198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6F77C96-1B21-4389-843E-27F44C6912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2045" y="4456953"/>
            <a:ext cx="5328366" cy="214597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E56562A-EF46-488E-A906-2F57EC835833}"/>
              </a:ext>
            </a:extLst>
          </p:cNvPr>
          <p:cNvSpPr txBox="1"/>
          <p:nvPr/>
        </p:nvSpPr>
        <p:spPr>
          <a:xfrm>
            <a:off x="2653989" y="3542147"/>
            <a:ext cx="929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95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02ED438-ACB4-46F9-9AC1-88BB978E966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962" y="3466003"/>
            <a:ext cx="1440000" cy="1442676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0A7840F5-9AA9-413F-AE8E-FA070B40999D}"/>
              </a:ext>
            </a:extLst>
          </p:cNvPr>
          <p:cNvSpPr txBox="1"/>
          <p:nvPr/>
        </p:nvSpPr>
        <p:spPr>
          <a:xfrm>
            <a:off x="2332327" y="3911479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8A68FBB-CD31-4989-8A59-8315D44F77C5}"/>
              </a:ext>
            </a:extLst>
          </p:cNvPr>
          <p:cNvSpPr txBox="1"/>
          <p:nvPr/>
        </p:nvSpPr>
        <p:spPr>
          <a:xfrm>
            <a:off x="9097599" y="47562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17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A4DAC79-5ED7-4922-A3F1-8CD14997E10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2245" y="-14876"/>
            <a:ext cx="1440000" cy="1349843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FDF2F64F-4918-4163-83CE-75D7DB289A67}"/>
              </a:ext>
            </a:extLst>
          </p:cNvPr>
          <p:cNvSpPr txBox="1"/>
          <p:nvPr/>
        </p:nvSpPr>
        <p:spPr>
          <a:xfrm>
            <a:off x="8410121" y="391144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8FB76222-AE7E-4BDC-83CD-E0B2F857F1C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572999" y="4456953"/>
            <a:ext cx="5322269" cy="2139881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7C906C6F-1F2B-41A8-8FAC-84AD2D6E34CB}"/>
              </a:ext>
            </a:extLst>
          </p:cNvPr>
          <p:cNvSpPr txBox="1"/>
          <p:nvPr/>
        </p:nvSpPr>
        <p:spPr>
          <a:xfrm>
            <a:off x="9177359" y="3510832"/>
            <a:ext cx="1182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31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5D5EC0C7-480D-4B9F-9373-4A6007A64C06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4753" y="3412877"/>
            <a:ext cx="2160000" cy="1193273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E9D45846-BD88-44F2-AC03-6B5F960EEFBE}"/>
              </a:ext>
            </a:extLst>
          </p:cNvPr>
          <p:cNvSpPr txBox="1"/>
          <p:nvPr/>
        </p:nvSpPr>
        <p:spPr>
          <a:xfrm>
            <a:off x="8530240" y="3845050"/>
            <a:ext cx="3794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31298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>
            <a:extLst>
              <a:ext uri="{FF2B5EF4-FFF2-40B4-BE49-F238E27FC236}">
                <a16:creationId xmlns:a16="http://schemas.microsoft.com/office/drawing/2014/main" id="{B97799FE-6F74-4AE8-9960-4DE2E645A5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604" y="4517267"/>
            <a:ext cx="5328366" cy="214597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0A2C9E8-C2C6-4A27-98F5-D0E31D905A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1265" y="4517267"/>
            <a:ext cx="5322269" cy="214597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EF2B59B5-788E-423E-8092-CD1582336B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31265" y="1053851"/>
            <a:ext cx="5322269" cy="2145978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73364DC5-C609-43AA-829A-1C46FF1ABDE5}"/>
              </a:ext>
            </a:extLst>
          </p:cNvPr>
          <p:cNvSpPr txBox="1"/>
          <p:nvPr/>
        </p:nvSpPr>
        <p:spPr>
          <a:xfrm>
            <a:off x="2669556" y="61449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70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55BCA53-0954-4DB6-93E7-F66C28543D9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36" y="-206090"/>
            <a:ext cx="2160000" cy="143071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54FB4E9-1C9C-4143-A104-FC91AF055D29}"/>
              </a:ext>
            </a:extLst>
          </p:cNvPr>
          <p:cNvSpPr txBox="1"/>
          <p:nvPr/>
        </p:nvSpPr>
        <p:spPr>
          <a:xfrm>
            <a:off x="2090233" y="372984"/>
            <a:ext cx="3961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B403449-440C-4DC4-B8A1-99BDF5D2E3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9701" y="1053851"/>
            <a:ext cx="5322269" cy="214597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84E7FD73-6754-4B2A-9760-8923D79BEFF4}"/>
              </a:ext>
            </a:extLst>
          </p:cNvPr>
          <p:cNvSpPr txBox="1"/>
          <p:nvPr/>
        </p:nvSpPr>
        <p:spPr>
          <a:xfrm>
            <a:off x="8850194" y="55820"/>
            <a:ext cx="929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9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8E8113FA-9330-4FD1-B59C-B2D2E7739C9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4649" y="24049"/>
            <a:ext cx="2160000" cy="120308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D219D458-0C77-4FCA-821F-E069D807A816}"/>
              </a:ext>
            </a:extLst>
          </p:cNvPr>
          <p:cNvSpPr txBox="1"/>
          <p:nvPr/>
        </p:nvSpPr>
        <p:spPr>
          <a:xfrm>
            <a:off x="8156860" y="385538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156C45A-9143-4F34-85EC-31DCFA5BCA11}"/>
              </a:ext>
            </a:extLst>
          </p:cNvPr>
          <p:cNvSpPr txBox="1"/>
          <p:nvPr/>
        </p:nvSpPr>
        <p:spPr>
          <a:xfrm>
            <a:off x="8833774" y="3515295"/>
            <a:ext cx="1038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8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923F602A-16FC-410F-9E9F-E7D7AA8AA81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2034" y="3526000"/>
            <a:ext cx="2160000" cy="1293439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72A1101B-D141-4785-8D00-9CD27A262D56}"/>
              </a:ext>
            </a:extLst>
          </p:cNvPr>
          <p:cNvSpPr txBox="1"/>
          <p:nvPr/>
        </p:nvSpPr>
        <p:spPr>
          <a:xfrm>
            <a:off x="8480238" y="3891432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eroni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PC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78F2D38-5E58-489E-8FD3-9F22438E08A0}"/>
              </a:ext>
            </a:extLst>
          </p:cNvPr>
          <p:cNvSpPr txBox="1"/>
          <p:nvPr/>
        </p:nvSpPr>
        <p:spPr>
          <a:xfrm>
            <a:off x="2601541" y="3508463"/>
            <a:ext cx="1182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7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BD7AFE72-3C61-4873-89EB-ED15C00B480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733" y="3370170"/>
            <a:ext cx="2160000" cy="143071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EEB7C343-2977-4AEA-A2A9-AA15E22FA366}"/>
              </a:ext>
            </a:extLst>
          </p:cNvPr>
          <p:cNvSpPr txBox="1"/>
          <p:nvPr/>
        </p:nvSpPr>
        <p:spPr>
          <a:xfrm>
            <a:off x="2213242" y="3891432"/>
            <a:ext cx="3882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25150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548B609A-B00C-4D18-97AB-B0788650F9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990" y="4480514"/>
            <a:ext cx="5322269" cy="2139881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40907ECB-9A3A-48C2-9735-2E83F2955311}"/>
              </a:ext>
            </a:extLst>
          </p:cNvPr>
          <p:cNvCxnSpPr/>
          <p:nvPr/>
        </p:nvCxnSpPr>
        <p:spPr>
          <a:xfrm>
            <a:off x="6096000" y="0"/>
            <a:ext cx="0" cy="685800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3EF60373-2A8A-4946-9F0F-93FBAD555BB6}"/>
              </a:ext>
            </a:extLst>
          </p:cNvPr>
          <p:cNvCxnSpPr/>
          <p:nvPr/>
        </p:nvCxnSpPr>
        <p:spPr>
          <a:xfrm>
            <a:off x="0" y="3435541"/>
            <a:ext cx="1219200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7E85B639-32FE-4B09-AA2F-03F85EDE56AC}"/>
              </a:ext>
            </a:extLst>
          </p:cNvPr>
          <p:cNvSpPr txBox="1"/>
          <p:nvPr/>
        </p:nvSpPr>
        <p:spPr>
          <a:xfrm>
            <a:off x="2692245" y="3526777"/>
            <a:ext cx="1013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72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7DC0468B-8C72-45B2-A391-45DFF177455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936" y="3580146"/>
            <a:ext cx="2160000" cy="104509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1ACE509F-B61D-4E2F-9BFD-C6D3CEE18EB6}"/>
              </a:ext>
            </a:extLst>
          </p:cNvPr>
          <p:cNvSpPr txBox="1"/>
          <p:nvPr/>
        </p:nvSpPr>
        <p:spPr>
          <a:xfrm>
            <a:off x="2322504" y="3867139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C2C327F5-4040-4AE3-AD2C-A09483284A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2990" y="1091195"/>
            <a:ext cx="5322269" cy="2145978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5B5DBC67-074D-4A30-A9FB-9889418F1E35}"/>
              </a:ext>
            </a:extLst>
          </p:cNvPr>
          <p:cNvSpPr txBox="1"/>
          <p:nvPr/>
        </p:nvSpPr>
        <p:spPr>
          <a:xfrm>
            <a:off x="2820128" y="97324"/>
            <a:ext cx="1038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27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142BCA85-8A48-433D-9418-C9357CF89EA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404" y="37268"/>
            <a:ext cx="2160000" cy="1069031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25D520C4-A37F-4AD3-85A0-1230BC54C00E}"/>
              </a:ext>
            </a:extLst>
          </p:cNvPr>
          <p:cNvSpPr txBox="1"/>
          <p:nvPr/>
        </p:nvSpPr>
        <p:spPr>
          <a:xfrm>
            <a:off x="2293242" y="442616"/>
            <a:ext cx="403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b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ingomona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.  CL5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221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5</TotalTime>
  <Words>328</Words>
  <Application>Microsoft Office PowerPoint</Application>
  <PresentationFormat>宽屏</PresentationFormat>
  <Paragraphs>74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 j</dc:creator>
  <cp:lastModifiedBy>z j</cp:lastModifiedBy>
  <cp:revision>68</cp:revision>
  <dcterms:created xsi:type="dcterms:W3CDTF">2021-09-14T07:13:35Z</dcterms:created>
  <dcterms:modified xsi:type="dcterms:W3CDTF">2022-07-14T14:10:49Z</dcterms:modified>
</cp:coreProperties>
</file>